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10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5C5A398-9946-23FF-0CF6-1C552965EF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5158A184-EADC-7FCC-FB4F-6D6EE157093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157161A8-971A-F0C6-057F-3FBF0B46A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D32CFE0-19A4-95A5-A174-10BB9249D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E45F118-DFF1-C3FC-CBC3-5E2532D98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773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E5FF56E-CACF-B538-E3BC-1B862A8CB0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023B1A8-EBC0-B928-9793-0E6AD38B25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3109C20-01EA-F50F-8A1B-25CE657F7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3F9950A-FA9B-15B1-8EA0-A2D2670277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470E5CB-C39C-48DD-6413-B9659627E3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532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2A3B000B-0899-8D8A-BAB0-19B146252D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21AF676-6E4C-1A3C-FED5-F7BBD72F75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E224283-56FE-700D-F760-3BB3C77D4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4450BC69-1D70-F530-CA72-FA91B8793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AB4B400F-162B-365C-8C49-64044BDFA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1015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E614270-E8D7-9C3E-605E-A66982FFF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552DA6FF-ABA9-E322-01E4-D19CDF8614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342DC18-486E-D894-B3D2-3D1CC08A4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4B4766C-0EA6-318D-65E9-382E2F241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6CCB0AD-95A1-DABB-9E9B-447B35D5B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843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06AC499-CCB3-EA4C-B8BC-0BF7FB712F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26529AD-F473-2911-4E34-B18034D27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7766B0F0-7B4A-1233-6F7B-88B032204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4A2DDD8-B5B4-1D4C-E12D-B03716475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FEF4D79-6C62-B3C0-47E1-C8C41258B8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0650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1E272BA-D9A0-49E4-CE12-2B29DF06A5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91740EC8-C7D6-A9CB-3B07-A7E81229EF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6EA156F6-8B9C-FD5B-7917-C989DD848C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677408CF-DF12-8A5A-27FE-516048F51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7B6E6E3-EE05-BF0F-3257-156830791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3C888324-7450-5485-2D38-F7503E364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7106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A94110F-4F00-EB31-B2F1-6AE97EAFBE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972A2282-E6CA-2424-E346-9F5934839C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0664EC52-5268-6409-D30A-153F8A1FE7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665098E5-4315-D85D-3610-EC6F9A8035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55D3F136-2631-365C-EC95-46A27BF9A7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C8836A6D-AFE4-D7D6-2DF1-E2E0B28CA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7E98CCB5-3E5E-70C2-ED2F-7A801EF49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3CD14AA4-3844-BF21-04D5-7C2C55D82D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2961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6733D79-9A54-712F-2203-272DD1067E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ACBA5C73-2066-DACA-B4D4-A68778365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C42FBAB5-1A38-3DA8-37CE-5D028834B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9DA5E90E-8D4C-0A6D-DEEB-A95C3D6D8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2250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8CD40778-D10F-B876-ADE7-BA0E465A1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E507FE5F-8E86-47E8-4951-2DFFB09CB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C4C45929-170F-9442-576C-BAE74F1635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266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AF79120-D356-46DD-8458-F47A9A0B1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6EF6C315-620A-496F-EF89-CB31DB1CC7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3D3D781D-6495-53F5-3C47-FD38E17343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6C5EFC2-4EA9-1724-E2D9-C43B01870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68240CB-60B7-ABC7-E51B-EC0739822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1A3E6E1-1A50-1FD5-44D6-A5B4387A0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30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8A89D97-FE2B-C43C-1348-DE35715937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43CE826A-26FD-31E6-EB2F-83A070CB45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4CD82DF9-388F-A3B7-1457-864B6D61B4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DCDC743B-4D63-E155-BCA5-E17C2D8491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E9351F06-56B2-43FC-76DC-09C325CA9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EC703FF-DDAD-7362-8E6D-367CE933C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39591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42D96D37-A677-5897-CA8F-57D211ECC2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F6D21E22-2289-DD9F-81CD-32F25370FD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451AF9E-BA89-C28F-CA51-47EA35F91B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FBB1B-49F7-4C99-AD5D-91D86CE10E3A}" type="datetimeFigureOut">
              <a:rPr lang="zh-CN" altLang="en-US" smtClean="0"/>
              <a:t>2022/7/2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3E7452C6-BB81-E67D-E939-CC045CA600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F71911C-70B7-C8ED-3E2C-0AC4A99FC2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4FD4C-064F-42CB-9888-F99C6F0F5D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4308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42030" y="861084"/>
            <a:ext cx="8585329" cy="4849567"/>
            <a:chOff x="1642030" y="861084"/>
            <a:chExt cx="8585329" cy="4849567"/>
          </a:xfrm>
        </p:grpSpPr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xmlns="" id="{D931DC0F-35F9-FDC0-9A73-0739D2AB923F}"/>
                </a:ext>
              </a:extLst>
            </p:cNvPr>
            <p:cNvGrpSpPr/>
            <p:nvPr/>
          </p:nvGrpSpPr>
          <p:grpSpPr>
            <a:xfrm>
              <a:off x="2204227" y="2475134"/>
              <a:ext cx="8023132" cy="1379553"/>
              <a:chOff x="2744395" y="3333410"/>
              <a:chExt cx="8023132" cy="1379553"/>
            </a:xfrm>
          </p:grpSpPr>
          <p:grpSp>
            <p:nvGrpSpPr>
              <p:cNvPr id="33" name="组合 32">
                <a:extLst>
                  <a:ext uri="{FF2B5EF4-FFF2-40B4-BE49-F238E27FC236}">
                    <a16:creationId xmlns:a16="http://schemas.microsoft.com/office/drawing/2014/main" xmlns="" id="{CC4BC143-8A7E-E5C6-2392-D6C4F89B6233}"/>
                  </a:ext>
                </a:extLst>
              </p:cNvPr>
              <p:cNvGrpSpPr/>
              <p:nvPr/>
            </p:nvGrpSpPr>
            <p:grpSpPr>
              <a:xfrm>
                <a:off x="2744395" y="3402173"/>
                <a:ext cx="7948580" cy="1310790"/>
                <a:chOff x="2163796" y="673586"/>
                <a:chExt cx="7948580" cy="1310790"/>
              </a:xfrm>
            </p:grpSpPr>
            <p:grpSp>
              <p:nvGrpSpPr>
                <p:cNvPr id="35" name="组合 37">
                  <a:extLst>
                    <a:ext uri="{FF2B5EF4-FFF2-40B4-BE49-F238E27FC236}">
                      <a16:creationId xmlns:a16="http://schemas.microsoft.com/office/drawing/2014/main" xmlns="" id="{FA2E1A44-C3A6-FE5C-E30F-6D27190AC3DC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400301" y="762001"/>
                  <a:ext cx="7712075" cy="1222375"/>
                  <a:chOff x="1145181" y="904005"/>
                  <a:chExt cx="7712368" cy="1223122"/>
                </a:xfrm>
              </p:grpSpPr>
              <p:cxnSp>
                <p:nvCxnSpPr>
                  <p:cNvPr id="37" name="直接连接符 36">
                    <a:extLst>
                      <a:ext uri="{FF2B5EF4-FFF2-40B4-BE49-F238E27FC236}">
                        <a16:creationId xmlns:a16="http://schemas.microsoft.com/office/drawing/2014/main" xmlns="" id="{AF8DB19E-0648-0090-3285-1537DCFA10F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1999288" y="1339246"/>
                    <a:ext cx="0" cy="157259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直接连接符 37">
                    <a:extLst>
                      <a:ext uri="{FF2B5EF4-FFF2-40B4-BE49-F238E27FC236}">
                        <a16:creationId xmlns:a16="http://schemas.microsoft.com/office/drawing/2014/main" xmlns="" id="{D3699D42-D998-03D9-3DF3-B0B5448A357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48454" y="1425023"/>
                    <a:ext cx="3625988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9" name="Rectangle 4">
                    <a:extLst>
                      <a:ext uri="{FF2B5EF4-FFF2-40B4-BE49-F238E27FC236}">
                        <a16:creationId xmlns:a16="http://schemas.microsoft.com/office/drawing/2014/main" xmlns="" id="{13342851-0BD4-BC83-1357-232B40D9E8D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145181" y="1727017"/>
                    <a:ext cx="7712368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</a:rPr>
                      <a:t>WT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GCGGCCGCCACCGCCTCCAGCTCGCCGTC</a:t>
                    </a:r>
                    <a:r>
                      <a:rPr lang="en-US" altLang="zh-CN" sz="1000" dirty="0">
                        <a:solidFill>
                          <a:srgbClr val="FF0000"/>
                        </a:solidFill>
                      </a:rPr>
                      <a:t>GACGCGCTCCACCGCGAGAT</a:t>
                    </a:r>
                    <a:r>
                      <a:rPr lang="en-US" altLang="zh-CN" sz="1000" u="sng" dirty="0">
                        <a:solidFill>
                          <a:srgbClr val="000000"/>
                        </a:solidFill>
                      </a:rPr>
                      <a:t>CGG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ATTCCTCGAGGTACTGTCTATATCACTA</a:t>
                    </a:r>
                  </a:p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b="1" i="1" dirty="0">
                        <a:solidFill>
                          <a:srgbClr val="000000"/>
                        </a:solidFill>
                      </a:rPr>
                      <a:t>gs3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</a:rPr>
                      <a:t> 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GCGGCCGCCACCGCCTCC----GCTCGAGGTACAATCTATCTCTAT-----------------------------------------------CTGTCTATATCACTA</a:t>
                    </a:r>
                  </a:p>
                </p:txBody>
              </p:sp>
              <p:sp>
                <p:nvSpPr>
                  <p:cNvPr id="40" name="TextBox 13">
                    <a:extLst>
                      <a:ext uri="{FF2B5EF4-FFF2-40B4-BE49-F238E27FC236}">
                        <a16:creationId xmlns:a16="http://schemas.microsoft.com/office/drawing/2014/main" xmlns="" id="{3D3416E7-685B-D337-82FD-B1C12F268663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955359" y="1353756"/>
                    <a:ext cx="261938" cy="369558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4127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endParaRPr lang="zh-CN" altLang="zh-CN" sz="1800">
                      <a:solidFill>
                        <a:srgbClr val="000000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41" name="TextBox 15">
                    <a:extLst>
                      <a:ext uri="{FF2B5EF4-FFF2-40B4-BE49-F238E27FC236}">
                        <a16:creationId xmlns:a16="http://schemas.microsoft.com/office/drawing/2014/main" xmlns="" id="{1712AED0-D941-941F-644F-A8A6A9BA426F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707834" y="1353756"/>
                    <a:ext cx="139700" cy="369558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4127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endParaRPr lang="zh-CN" altLang="zh-CN" sz="1800">
                      <a:solidFill>
                        <a:srgbClr val="000000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42" name="TextBox 16">
                    <a:extLst>
                      <a:ext uri="{FF2B5EF4-FFF2-40B4-BE49-F238E27FC236}">
                        <a16:creationId xmlns:a16="http://schemas.microsoft.com/office/drawing/2014/main" xmlns="" id="{8F031B37-E1BD-C449-A6F9-19B0A968D5C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17434" y="1356931"/>
                    <a:ext cx="139700" cy="369558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4127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endParaRPr lang="zh-CN" altLang="zh-CN" sz="1800">
                      <a:solidFill>
                        <a:srgbClr val="000000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sp>
                <p:nvSpPr>
                  <p:cNvPr id="43" name="TextBox 17">
                    <a:extLst>
                      <a:ext uri="{FF2B5EF4-FFF2-40B4-BE49-F238E27FC236}">
                        <a16:creationId xmlns:a16="http://schemas.microsoft.com/office/drawing/2014/main" xmlns="" id="{BFD0DAE0-B007-4616-1972-4A03A7569597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653984" y="1355344"/>
                    <a:ext cx="139700" cy="369558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4127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endParaRPr lang="zh-CN" altLang="zh-CN" sz="1800">
                      <a:solidFill>
                        <a:srgbClr val="000000"/>
                      </a:solidFill>
                      <a:latin typeface="Calibri" panose="020F0502020204030204" pitchFamily="34" charset="0"/>
                    </a:endParaRPr>
                  </a:p>
                </p:txBody>
              </p:sp>
              <p:cxnSp>
                <p:nvCxnSpPr>
                  <p:cNvPr id="44" name="直接连接符 43">
                    <a:extLst>
                      <a:ext uri="{FF2B5EF4-FFF2-40B4-BE49-F238E27FC236}">
                        <a16:creationId xmlns:a16="http://schemas.microsoft.com/office/drawing/2014/main" xmlns="" id="{D0059854-4C39-F793-23A1-9CC0A302F58A}"/>
                      </a:ext>
                    </a:extLst>
                  </p:cNvPr>
                  <p:cNvCxnSpPr/>
                  <p:nvPr/>
                </p:nvCxnSpPr>
                <p:spPr bwMode="auto">
                  <a:xfrm flipV="1">
                    <a:off x="3021677" y="1208991"/>
                    <a:ext cx="0" cy="544846"/>
                  </a:xfrm>
                  <a:prstGeom prst="line">
                    <a:avLst/>
                  </a:prstGeom>
                  <a:ln>
                    <a:noFill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" name="矩形 2">
                    <a:extLst>
                      <a:ext uri="{FF2B5EF4-FFF2-40B4-BE49-F238E27FC236}">
                        <a16:creationId xmlns:a16="http://schemas.microsoft.com/office/drawing/2014/main" xmlns="" id="{7CE4EECA-8964-FB80-0BD0-C3B0A0564B62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145181" y="904005"/>
                    <a:ext cx="3174843" cy="36933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2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85 GACGCGCTCCACCGCGAGAT</a:t>
                    </a:r>
                    <a:r>
                      <a:rPr lang="en-US" altLang="zh-CN" sz="1200" u="sng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GG</a:t>
                    </a:r>
                    <a:r>
                      <a:rPr lang="en-US" altLang="zh-CN" sz="12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107</a:t>
                    </a:r>
                    <a:r>
                      <a:rPr lang="en-US" altLang="zh-CN" sz="1800" dirty="0">
                        <a:solidFill>
                          <a:srgbClr val="000000"/>
                        </a:solidFill>
                        <a:latin typeface="Calibri" panose="020F0502020204030204" pitchFamily="34" charset="0"/>
                      </a:rPr>
                      <a:t> </a:t>
                    </a:r>
                    <a:r>
                      <a:rPr lang="zh-CN" altLang="zh-CN" sz="1800" dirty="0">
                        <a:solidFill>
                          <a:srgbClr val="000000"/>
                        </a:solidFill>
                        <a:latin typeface="Calibri" panose="020F0502020204030204" pitchFamily="34" charset="0"/>
                      </a:rPr>
                      <a:t> </a:t>
                    </a:r>
                  </a:p>
                </p:txBody>
              </p:sp>
              <p:sp>
                <p:nvSpPr>
                  <p:cNvPr id="46" name="箭头: 五边形 12">
                    <a:extLst>
                      <a:ext uri="{FF2B5EF4-FFF2-40B4-BE49-F238E27FC236}">
                        <a16:creationId xmlns:a16="http://schemas.microsoft.com/office/drawing/2014/main" xmlns="" id="{7EF8E919-AA09-BEC9-ADB7-AEF2100B8E6E}"/>
                      </a:ext>
                    </a:extLst>
                  </p:cNvPr>
                  <p:cNvSpPr/>
                  <p:nvPr/>
                </p:nvSpPr>
                <p:spPr>
                  <a:xfrm>
                    <a:off x="4402855" y="1355131"/>
                    <a:ext cx="838232" cy="141374"/>
                  </a:xfrm>
                  <a:prstGeom prst="homePlate">
                    <a:avLst/>
                  </a:prstGeom>
                  <a:solidFill>
                    <a:srgbClr val="92D05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zh-CN" altLang="en-US">
                      <a:solidFill>
                        <a:srgbClr val="FFFFFF"/>
                      </a:solidFill>
                      <a:latin typeface="Arial"/>
                      <a:ea typeface="宋体"/>
                    </a:endParaRPr>
                  </a:p>
                </p:txBody>
              </p:sp>
              <p:cxnSp>
                <p:nvCxnSpPr>
                  <p:cNvPr id="47" name="直接连接符 46">
                    <a:extLst>
                      <a:ext uri="{FF2B5EF4-FFF2-40B4-BE49-F238E27FC236}">
                        <a16:creationId xmlns:a16="http://schemas.microsoft.com/office/drawing/2014/main" xmlns="" id="{03067247-CAE8-62B9-DB65-CA60778D626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1430942" y="1224876"/>
                    <a:ext cx="577872" cy="108016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直接连接符 47">
                    <a:extLst>
                      <a:ext uri="{FF2B5EF4-FFF2-40B4-BE49-F238E27FC236}">
                        <a16:creationId xmlns:a16="http://schemas.microsoft.com/office/drawing/2014/main" xmlns="" id="{52EE1BA0-4F29-0A60-CA3C-FB71A79EC1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V="1">
                    <a:off x="1999288" y="1208991"/>
                    <a:ext cx="1782831" cy="11437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6" name="文本框 38">
                  <a:extLst>
                    <a:ext uri="{FF2B5EF4-FFF2-40B4-BE49-F238E27FC236}">
                      <a16:creationId xmlns:a16="http://schemas.microsoft.com/office/drawing/2014/main" xmlns="" id="{97A609D2-831E-584B-1E17-07E551EBA3C6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163796" y="673586"/>
                  <a:ext cx="320922" cy="3385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lang="en-US" altLang="zh-CN" sz="16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</a:t>
                  </a:r>
                  <a:endParaRPr lang="zh-CN" altLang="en-US" sz="16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xmlns="" id="{5A58347B-F225-D33B-BFA1-1FA2CB27E4CC}"/>
                  </a:ext>
                </a:extLst>
              </p:cNvPr>
              <p:cNvSpPr/>
              <p:nvPr/>
            </p:nvSpPr>
            <p:spPr>
              <a:xfrm>
                <a:off x="2789853" y="3333410"/>
                <a:ext cx="7977674" cy="136527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xmlns="" id="{973D0831-3F24-0B28-019E-461F88FDAB84}"/>
                </a:ext>
              </a:extLst>
            </p:cNvPr>
            <p:cNvGrpSpPr/>
            <p:nvPr/>
          </p:nvGrpSpPr>
          <p:grpSpPr>
            <a:xfrm>
              <a:off x="2204227" y="3961119"/>
              <a:ext cx="6042686" cy="1749532"/>
              <a:chOff x="2830726" y="4893677"/>
              <a:chExt cx="6042686" cy="1749532"/>
            </a:xfrm>
          </p:grpSpPr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xmlns="" id="{93ADB5E4-5613-FC39-3E82-FE3AD9D2586C}"/>
                  </a:ext>
                </a:extLst>
              </p:cNvPr>
              <p:cNvGrpSpPr/>
              <p:nvPr/>
            </p:nvGrpSpPr>
            <p:grpSpPr>
              <a:xfrm>
                <a:off x="2830726" y="4893677"/>
                <a:ext cx="5993443" cy="1660497"/>
                <a:chOff x="2327079" y="2559425"/>
                <a:chExt cx="5993443" cy="1660497"/>
              </a:xfrm>
            </p:grpSpPr>
            <p:grpSp>
              <p:nvGrpSpPr>
                <p:cNvPr id="10" name="组合 36">
                  <a:extLst>
                    <a:ext uri="{FF2B5EF4-FFF2-40B4-BE49-F238E27FC236}">
                      <a16:creationId xmlns:a16="http://schemas.microsoft.com/office/drawing/2014/main" xmlns="" id="{0911B2B1-17B2-BB7E-4C4D-98DF1BD93625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565834" y="2590801"/>
                  <a:ext cx="5754688" cy="1629121"/>
                  <a:chOff x="1196419" y="3270811"/>
                  <a:chExt cx="5755102" cy="1629173"/>
                </a:xfrm>
              </p:grpSpPr>
              <p:sp>
                <p:nvSpPr>
                  <p:cNvPr id="12" name="Rectangle 36">
                    <a:extLst>
                      <a:ext uri="{FF2B5EF4-FFF2-40B4-BE49-F238E27FC236}">
                        <a16:creationId xmlns:a16="http://schemas.microsoft.com/office/drawing/2014/main" xmlns="" id="{A59A2841-B798-CA86-6986-FECAA1B9A7D4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196419" y="4499874"/>
                    <a:ext cx="5755102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b="1" dirty="0">
                        <a:solidFill>
                          <a:srgbClr val="000000"/>
                        </a:solidFill>
                      </a:rPr>
                      <a:t>WT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      CGGTGCCG</a:t>
                    </a:r>
                    <a:r>
                      <a:rPr lang="en-US" altLang="zh-CN" sz="1000" u="sng" dirty="0">
                        <a:solidFill>
                          <a:srgbClr val="000000"/>
                        </a:solidFill>
                      </a:rPr>
                      <a:t>CCA</a:t>
                    </a:r>
                    <a:r>
                      <a:rPr lang="en-US" altLang="zh-CN" sz="1000" dirty="0">
                        <a:solidFill>
                          <a:srgbClr val="FF0000"/>
                        </a:solidFill>
                      </a:rPr>
                      <a:t>CCGACTCGAGCTGTGCTCTC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TCTCTTCTGTCAACCCAGCCATGGG</a:t>
                    </a:r>
                  </a:p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b="1" i="1" dirty="0">
                        <a:solidFill>
                          <a:srgbClr val="000000"/>
                        </a:solidFill>
                      </a:rPr>
                      <a:t>ipa1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     CGGTGC-------------------------------------------- TCTCTCTCTTCTGTCAACCCAGCCATGGG</a:t>
                    </a:r>
                  </a:p>
                </p:txBody>
              </p:sp>
              <p:grpSp>
                <p:nvGrpSpPr>
                  <p:cNvPr id="13" name="组合 16">
                    <a:extLst>
                      <a:ext uri="{FF2B5EF4-FFF2-40B4-BE49-F238E27FC236}">
                        <a16:creationId xmlns:a16="http://schemas.microsoft.com/office/drawing/2014/main" xmlns="" id="{E621CB3D-F32D-F60D-440A-130C04E98C48}"/>
                      </a:ext>
                    </a:extLst>
                  </p:cNvPr>
                  <p:cNvGrpSpPr>
                    <a:grpSpLocks/>
                  </p:cNvGrpSpPr>
                  <p:nvPr/>
                </p:nvGrpSpPr>
                <p:grpSpPr bwMode="auto">
                  <a:xfrm>
                    <a:off x="1281887" y="3270811"/>
                    <a:ext cx="5194520" cy="1105140"/>
                    <a:chOff x="1071128" y="4571761"/>
                    <a:chExt cx="5194520" cy="1105140"/>
                  </a:xfrm>
                </p:grpSpPr>
                <p:cxnSp>
                  <p:nvCxnSpPr>
                    <p:cNvPr id="14" name="直接连接符 13">
                      <a:extLst>
                        <a:ext uri="{FF2B5EF4-FFF2-40B4-BE49-F238E27FC236}">
                          <a16:creationId xmlns:a16="http://schemas.microsoft.com/office/drawing/2014/main" xmlns="" id="{D23303C6-A6DE-C7CD-933A-AD4253C4DF8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070957" y="5587793"/>
                      <a:ext cx="3722956" cy="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5" name="直接连接符 14">
                      <a:extLst>
                        <a:ext uri="{FF2B5EF4-FFF2-40B4-BE49-F238E27FC236}">
                          <a16:creationId xmlns:a16="http://schemas.microsoft.com/office/drawing/2014/main" xmlns="" id="{C60811F4-62BC-9847-87A3-ED1C897ADF2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 flipV="1">
                      <a:off x="2056866" y="5109941"/>
                      <a:ext cx="2189320" cy="142880"/>
                    </a:xfrm>
                    <a:prstGeom prst="line">
                      <a:avLst/>
                    </a:prstGeom>
                    <a:ln w="41275">
                      <a:noFill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6" name="直接连接符 15">
                      <a:extLst>
                        <a:ext uri="{FF2B5EF4-FFF2-40B4-BE49-F238E27FC236}">
                          <a16:creationId xmlns:a16="http://schemas.microsoft.com/office/drawing/2014/main" xmlns="" id="{25AD543C-D886-954E-4F4D-00607AAD8E7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 bwMode="auto">
                    <a:xfrm flipV="1">
                      <a:off x="3428565" y="5409988"/>
                      <a:ext cx="0" cy="266708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" name="直接连接符 16">
                      <a:extLst>
                        <a:ext uri="{FF2B5EF4-FFF2-40B4-BE49-F238E27FC236}">
                          <a16:creationId xmlns:a16="http://schemas.microsoft.com/office/drawing/2014/main" xmlns="" id="{5602D6C9-F22B-392D-F5AF-94052A18F6C4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2323585" y="5330610"/>
                      <a:ext cx="1120856" cy="84141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" name="直接连接符 17">
                      <a:extLst>
                        <a:ext uri="{FF2B5EF4-FFF2-40B4-BE49-F238E27FC236}">
                          <a16:creationId xmlns:a16="http://schemas.microsoft.com/office/drawing/2014/main" xmlns="" id="{ACB1E1FE-9FD8-FC19-1995-90BCAD25299A}"/>
                        </a:ext>
                      </a:extLst>
                    </p:cNvPr>
                    <p:cNvCxnSpPr/>
                    <p:nvPr/>
                  </p:nvCxnSpPr>
                  <p:spPr bwMode="auto">
                    <a:xfrm flipV="1">
                      <a:off x="3460317" y="5332198"/>
                      <a:ext cx="1120856" cy="8414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9" name="矩形 6">
                      <a:extLst>
                        <a:ext uri="{FF2B5EF4-FFF2-40B4-BE49-F238E27FC236}">
                          <a16:creationId xmlns:a16="http://schemas.microsoft.com/office/drawing/2014/main" xmlns="" id="{962B3CE8-1C0B-ADD3-4088-7D7107786578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965231" y="5086861"/>
                      <a:ext cx="3142207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Char char="•"/>
                        <a:defRPr sz="3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har char="–"/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har char="•"/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har char="–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algn="ctr" fontAlgn="base"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</a:pP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4 </a:t>
                      </a:r>
                      <a:r>
                        <a:rPr lang="en-US" altLang="zh-CN" sz="1200" u="sng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GACTCGAGCTGTGCTCTC 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zh-CN" sz="12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6</a:t>
                      </a:r>
                    </a:p>
                  </p:txBody>
                </p:sp>
                <p:sp>
                  <p:nvSpPr>
                    <p:cNvPr id="20" name="矩形 30">
                      <a:extLst>
                        <a:ext uri="{FF2B5EF4-FFF2-40B4-BE49-F238E27FC236}">
                          <a16:creationId xmlns:a16="http://schemas.microsoft.com/office/drawing/2014/main" xmlns="" id="{2C24DD79-8DA8-60A3-DB72-09829AA5496F}"/>
                        </a:ext>
                      </a:extLst>
                    </p:cNvPr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539068" y="4796881"/>
                      <a:ext cx="2726580" cy="27699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Char char="•"/>
                        <a:defRPr sz="3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har char="–"/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har char="•"/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har char="–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</a:pPr>
                      <a:r>
                        <a:rPr lang="en-US" altLang="zh-CN" sz="12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9 </a:t>
                      </a:r>
                      <a:r>
                        <a:rPr lang="en-US" altLang="zh-CN" sz="120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TGCTCTC</a:t>
                      </a:r>
                      <a:r>
                        <a:rPr lang="en-US" altLang="zh-CN" sz="12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CTTCTGTCA 888</a:t>
                      </a:r>
                    </a:p>
                  </p:txBody>
                </p:sp>
                <p:cxnSp>
                  <p:nvCxnSpPr>
                    <p:cNvPr id="21" name="直接连接符 20">
                      <a:extLst>
                        <a:ext uri="{FF2B5EF4-FFF2-40B4-BE49-F238E27FC236}">
                          <a16:creationId xmlns:a16="http://schemas.microsoft.com/office/drawing/2014/main" xmlns="" id="{B116A9AA-02F8-AE3A-A5CA-61655E744BEC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089012" y="4997224"/>
                      <a:ext cx="0" cy="16034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直接连接符 21">
                      <a:extLst>
                        <a:ext uri="{FF2B5EF4-FFF2-40B4-BE49-F238E27FC236}">
                          <a16:creationId xmlns:a16="http://schemas.microsoft.com/office/drawing/2014/main" xmlns="" id="{4D5F550B-61AA-F97B-8391-DA295B7BC848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187444" y="4995637"/>
                      <a:ext cx="0" cy="160342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" name="直接连接符 22">
                      <a:extLst>
                        <a:ext uri="{FF2B5EF4-FFF2-40B4-BE49-F238E27FC236}">
                          <a16:creationId xmlns:a16="http://schemas.microsoft.com/office/drawing/2014/main" xmlns="" id="{8EC23490-798C-0352-AF6D-C71003180E20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303340" y="4995637"/>
                      <a:ext cx="0" cy="160342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" name="直接连接符 23">
                      <a:extLst>
                        <a:ext uri="{FF2B5EF4-FFF2-40B4-BE49-F238E27FC236}">
                          <a16:creationId xmlns:a16="http://schemas.microsoft.com/office/drawing/2014/main" xmlns="" id="{264D1B36-5FC6-72B0-76AE-0A4D07DCABF1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520843" y="4992462"/>
                      <a:ext cx="0" cy="160342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" name="直接连接符 24">
                      <a:extLst>
                        <a:ext uri="{FF2B5EF4-FFF2-40B4-BE49-F238E27FC236}">
                          <a16:creationId xmlns:a16="http://schemas.microsoft.com/office/drawing/2014/main" xmlns="" id="{BF5663F2-DC3E-495B-C990-8D421445C5F3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411297" y="4995637"/>
                      <a:ext cx="0" cy="160342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直接连接符 25">
                      <a:extLst>
                        <a:ext uri="{FF2B5EF4-FFF2-40B4-BE49-F238E27FC236}">
                          <a16:creationId xmlns:a16="http://schemas.microsoft.com/office/drawing/2014/main" xmlns="" id="{591A9217-B523-E3F1-5163-EA70F717D357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624038" y="4995637"/>
                      <a:ext cx="0" cy="160342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" name="直接连接符 26">
                      <a:extLst>
                        <a:ext uri="{FF2B5EF4-FFF2-40B4-BE49-F238E27FC236}">
                          <a16:creationId xmlns:a16="http://schemas.microsoft.com/office/drawing/2014/main" xmlns="" id="{1998E3D4-08B3-3A7B-B534-29865D550C58}"/>
                        </a:ext>
                      </a:extLst>
                    </p:cNvPr>
                    <p:cNvCxnSpPr/>
                    <p:nvPr/>
                  </p:nvCxnSpPr>
                  <p:spPr bwMode="auto">
                    <a:xfrm>
                      <a:off x="4724058" y="4994049"/>
                      <a:ext cx="0" cy="160343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8" name="TextBox 28">
                      <a:extLst>
                        <a:ext uri="{FF2B5EF4-FFF2-40B4-BE49-F238E27FC236}">
                          <a16:creationId xmlns:a16="http://schemas.microsoft.com/office/drawing/2014/main" xmlns="" id="{70FC4F51-B361-D382-02AC-7C82EC2EFB58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4411127" y="4571761"/>
                      <a:ext cx="1828412" cy="30777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lvl1pPr>
                        <a:spcBef>
                          <a:spcPct val="20000"/>
                        </a:spcBef>
                        <a:buChar char="•"/>
                        <a:defRPr sz="32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Char char="–"/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Char char="•"/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Char char="–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Char char="»"/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fontAlgn="base">
                        <a:spcBef>
                          <a:spcPct val="0"/>
                        </a:spcBef>
                        <a:spcAft>
                          <a:spcPct val="0"/>
                        </a:spcAft>
                        <a:buNone/>
                      </a:pPr>
                      <a:r>
                        <a:rPr lang="en-US" altLang="zh-CN" sz="14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miR156 target site</a:t>
                      </a:r>
                      <a:endParaRPr lang="zh-CN" altLang="en-US" sz="14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29" name="直接连接符 28">
                      <a:extLst>
                        <a:ext uri="{FF2B5EF4-FFF2-40B4-BE49-F238E27FC236}">
                          <a16:creationId xmlns:a16="http://schemas.microsoft.com/office/drawing/2014/main" xmlns="" id="{3A6468AC-AD4A-544A-5192-FE65488B8E1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979466" y="4997224"/>
                      <a:ext cx="0" cy="15875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0" name="矩形 29">
                      <a:extLst>
                        <a:ext uri="{FF2B5EF4-FFF2-40B4-BE49-F238E27FC236}">
                          <a16:creationId xmlns:a16="http://schemas.microsoft.com/office/drawing/2014/main" xmlns="" id="{6E6FB2C2-FA7A-6FD4-5A31-D54D3C44C84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447222" y="5510004"/>
                      <a:ext cx="457233" cy="163517"/>
                    </a:xfrm>
                    <a:prstGeom prst="rect">
                      <a:avLst/>
                    </a:prstGeom>
                    <a:solidFill>
                      <a:srgbClr val="92D050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/>
                      </a:pPr>
                      <a:endParaRPr lang="zh-CN" altLang="en-US">
                        <a:solidFill>
                          <a:srgbClr val="FFFFFF"/>
                        </a:solidFill>
                        <a:latin typeface="Arial"/>
                        <a:ea typeface="宋体"/>
                      </a:endParaRPr>
                    </a:p>
                  </p:txBody>
                </p:sp>
                <p:sp>
                  <p:nvSpPr>
                    <p:cNvPr id="31" name="矩形 30">
                      <a:extLst>
                        <a:ext uri="{FF2B5EF4-FFF2-40B4-BE49-F238E27FC236}">
                          <a16:creationId xmlns:a16="http://schemas.microsoft.com/office/drawing/2014/main" xmlns="" id="{C097058D-D024-C453-49B4-CE4B45E1C87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931641" y="5517941"/>
                      <a:ext cx="249256" cy="157168"/>
                    </a:xfrm>
                    <a:prstGeom prst="rect">
                      <a:avLst/>
                    </a:prstGeom>
                    <a:solidFill>
                      <a:srgbClr val="92D050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/>
                      </a:pPr>
                      <a:endParaRPr lang="zh-CN" altLang="en-US">
                        <a:solidFill>
                          <a:srgbClr val="FFFFFF"/>
                        </a:solidFill>
                        <a:latin typeface="Arial"/>
                        <a:ea typeface="宋体"/>
                      </a:endParaRPr>
                    </a:p>
                  </p:txBody>
                </p:sp>
                <p:sp>
                  <p:nvSpPr>
                    <p:cNvPr id="32" name="箭头: 五边形 35">
                      <a:extLst>
                        <a:ext uri="{FF2B5EF4-FFF2-40B4-BE49-F238E27FC236}">
                          <a16:creationId xmlns:a16="http://schemas.microsoft.com/office/drawing/2014/main" xmlns="" id="{3C12EAEF-7457-DC1B-945B-E0996299435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280916" y="5517941"/>
                      <a:ext cx="1163722" cy="157168"/>
                    </a:xfrm>
                    <a:prstGeom prst="homePlate">
                      <a:avLst/>
                    </a:prstGeom>
                    <a:solidFill>
                      <a:srgbClr val="92D050"/>
                    </a:solidFill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  <a:defRPr/>
                      </a:pPr>
                      <a:endParaRPr lang="zh-CN" altLang="en-US">
                        <a:solidFill>
                          <a:srgbClr val="FFFFFF"/>
                        </a:solidFill>
                        <a:latin typeface="Arial"/>
                        <a:ea typeface="宋体"/>
                      </a:endParaRPr>
                    </a:p>
                  </p:txBody>
                </p:sp>
              </p:grpSp>
            </p:grpSp>
            <p:sp>
              <p:nvSpPr>
                <p:cNvPr id="11" name="文本框 39">
                  <a:extLst>
                    <a:ext uri="{FF2B5EF4-FFF2-40B4-BE49-F238E27FC236}">
                      <a16:creationId xmlns:a16="http://schemas.microsoft.com/office/drawing/2014/main" xmlns="" id="{B3ABA985-4506-104C-7AF8-66D37085F953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327079" y="2559425"/>
                  <a:ext cx="332142" cy="3385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lang="en-US" altLang="zh-CN" sz="16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zh-CN" altLang="en-US" sz="16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xmlns="" id="{1C119B71-DE72-4E90-7206-9B5ACA72E367}"/>
                  </a:ext>
                </a:extLst>
              </p:cNvPr>
              <p:cNvSpPr/>
              <p:nvPr/>
            </p:nvSpPr>
            <p:spPr>
              <a:xfrm>
                <a:off x="2887511" y="4921670"/>
                <a:ext cx="5985901" cy="172153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grpSp>
          <p:nvGrpSpPr>
            <p:cNvPr id="64" name="组合 63">
              <a:extLst>
                <a:ext uri="{FF2B5EF4-FFF2-40B4-BE49-F238E27FC236}">
                  <a16:creationId xmlns:a16="http://schemas.microsoft.com/office/drawing/2014/main" xmlns="" id="{9B67A9D5-93C6-2E31-52A2-862BB34FCC72}"/>
                </a:ext>
              </a:extLst>
            </p:cNvPr>
            <p:cNvGrpSpPr/>
            <p:nvPr/>
          </p:nvGrpSpPr>
          <p:grpSpPr>
            <a:xfrm>
              <a:off x="1642030" y="861084"/>
              <a:ext cx="6023011" cy="1536263"/>
              <a:chOff x="2419337" y="1795251"/>
              <a:chExt cx="6023011" cy="1536263"/>
            </a:xfrm>
          </p:grpSpPr>
          <p:grpSp>
            <p:nvGrpSpPr>
              <p:cNvPr id="65" name="组合 64">
                <a:extLst>
                  <a:ext uri="{FF2B5EF4-FFF2-40B4-BE49-F238E27FC236}">
                    <a16:creationId xmlns:a16="http://schemas.microsoft.com/office/drawing/2014/main" xmlns="" id="{8A812CEF-8CAB-112C-9E26-A26A88026E97}"/>
                  </a:ext>
                </a:extLst>
              </p:cNvPr>
              <p:cNvGrpSpPr/>
              <p:nvPr/>
            </p:nvGrpSpPr>
            <p:grpSpPr>
              <a:xfrm>
                <a:off x="2419337" y="1795251"/>
                <a:ext cx="5955476" cy="1334496"/>
                <a:chOff x="2062488" y="3306642"/>
                <a:chExt cx="5955476" cy="1334496"/>
              </a:xfrm>
            </p:grpSpPr>
            <p:grpSp>
              <p:nvGrpSpPr>
                <p:cNvPr id="67" name="组合 2">
                  <a:extLst>
                    <a:ext uri="{FF2B5EF4-FFF2-40B4-BE49-F238E27FC236}">
                      <a16:creationId xmlns:a16="http://schemas.microsoft.com/office/drawing/2014/main" xmlns="" id="{20AE83C5-AEEE-9D57-2C8C-1E4424C055D2}"/>
                    </a:ext>
                  </a:extLst>
                </p:cNvPr>
                <p:cNvGrpSpPr>
                  <a:grpSpLocks/>
                </p:cNvGrpSpPr>
                <p:nvPr/>
              </p:nvGrpSpPr>
              <p:grpSpPr bwMode="auto">
                <a:xfrm>
                  <a:off x="2062488" y="3454401"/>
                  <a:ext cx="5955476" cy="1186737"/>
                  <a:chOff x="591607" y="2087562"/>
                  <a:chExt cx="6125406" cy="1187177"/>
                </a:xfrm>
              </p:grpSpPr>
              <p:cxnSp>
                <p:nvCxnSpPr>
                  <p:cNvPr id="69" name="直接连接符 68">
                    <a:extLst>
                      <a:ext uri="{FF2B5EF4-FFF2-40B4-BE49-F238E27FC236}">
                        <a16:creationId xmlns:a16="http://schemas.microsoft.com/office/drawing/2014/main" xmlns="" id="{1F5A0540-C9AE-A03D-4116-58E15008ED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78317" y="2681507"/>
                    <a:ext cx="4909820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直接连接符 69">
                    <a:extLst>
                      <a:ext uri="{FF2B5EF4-FFF2-40B4-BE49-F238E27FC236}">
                        <a16:creationId xmlns:a16="http://schemas.microsoft.com/office/drawing/2014/main" xmlns="" id="{ED597555-BB86-BD0A-1933-CFC69B387D9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2455928" y="2462351"/>
                    <a:ext cx="0" cy="157221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直接连接符 70">
                    <a:extLst>
                      <a:ext uri="{FF2B5EF4-FFF2-40B4-BE49-F238E27FC236}">
                        <a16:creationId xmlns:a16="http://schemas.microsoft.com/office/drawing/2014/main" xmlns="" id="{62010C54-5366-4F3F-8AE4-F0C71A00F3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>
                    <a:off x="1887714" y="2348009"/>
                    <a:ext cx="578010" cy="10799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2" name="直接连接符 71">
                    <a:extLst>
                      <a:ext uri="{FF2B5EF4-FFF2-40B4-BE49-F238E27FC236}">
                        <a16:creationId xmlns:a16="http://schemas.microsoft.com/office/drawing/2014/main" xmlns="" id="{3BE31393-4C75-1ED2-812E-B7EA5D28EB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 bwMode="auto">
                  <a:xfrm flipV="1">
                    <a:off x="2467357" y="2341656"/>
                    <a:ext cx="1783014" cy="114342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3" name="矩形 38">
                    <a:extLst>
                      <a:ext uri="{FF2B5EF4-FFF2-40B4-BE49-F238E27FC236}">
                        <a16:creationId xmlns:a16="http://schemas.microsoft.com/office/drawing/2014/main" xmlns="" id="{B6BEA652-5EB3-FB75-8C5A-8EF85D8628E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1481074" y="2087562"/>
                    <a:ext cx="3227512" cy="27710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2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35 GCCGCTCATCCGCGCCGACG</a:t>
                    </a:r>
                    <a:r>
                      <a:rPr lang="en-US" altLang="zh-CN" sz="1200" u="sng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GG</a:t>
                    </a:r>
                    <a:r>
                      <a:rPr lang="en-US" altLang="zh-CN" sz="12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157</a:t>
                    </a:r>
                  </a:p>
                </p:txBody>
              </p:sp>
              <p:sp>
                <p:nvSpPr>
                  <p:cNvPr id="74" name="Rectangle 23">
                    <a:extLst>
                      <a:ext uri="{FF2B5EF4-FFF2-40B4-BE49-F238E27FC236}">
                        <a16:creationId xmlns:a16="http://schemas.microsoft.com/office/drawing/2014/main" xmlns="" id="{EC76EA10-2565-4885-C480-9A69D5BCECEA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591607" y="2874481"/>
                    <a:ext cx="6125406" cy="400258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  <p:txBody>
                  <a:bodyPr wrap="none" anchor="ctr">
                    <a:spAutoFit/>
                  </a:bodyPr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                         </a:t>
                    </a:r>
                    <a:r>
                      <a:rPr lang="en-US" altLang="zh-CN" sz="1000" b="1" dirty="0">
                        <a:solidFill>
                          <a:srgbClr val="000000"/>
                        </a:solidFill>
                      </a:rPr>
                      <a:t>WT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   CATCGC</a:t>
                    </a:r>
                    <a:r>
                      <a:rPr lang="en-US" altLang="zh-CN" sz="1000" dirty="0">
                        <a:solidFill>
                          <a:srgbClr val="FF0000"/>
                        </a:solidFill>
                      </a:rPr>
                      <a:t>GCCGCTCATCCGCGCCGACG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AGGCGGGCACCGCGCGCGCC</a:t>
                    </a:r>
                  </a:p>
                  <a:p>
                    <a:pPr fontAlgn="base">
                      <a:spcBef>
                        <a:spcPct val="0"/>
                      </a:spcBef>
                      <a:spcAft>
                        <a:spcPct val="0"/>
                      </a:spcAft>
                      <a:buNone/>
                    </a:pP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                        </a:t>
                    </a:r>
                    <a:r>
                      <a:rPr lang="en-US" altLang="zh-CN" sz="1000" b="1" i="1" dirty="0">
                        <a:solidFill>
                          <a:srgbClr val="000000"/>
                        </a:solidFill>
                      </a:rPr>
                      <a:t>gn1a</a:t>
                    </a:r>
                    <a:r>
                      <a:rPr lang="en-US" altLang="zh-CN" sz="1000" dirty="0">
                        <a:solidFill>
                          <a:srgbClr val="000000"/>
                        </a:solidFill>
                      </a:rPr>
                      <a:t>     CATCGCGCCGCTCATCCGCGCC--ACGAGGCGGGCACCGCGCGCGCC</a:t>
                    </a:r>
                  </a:p>
                </p:txBody>
              </p:sp>
              <p:sp>
                <p:nvSpPr>
                  <p:cNvPr id="75" name="矩形 74">
                    <a:extLst>
                      <a:ext uri="{FF2B5EF4-FFF2-40B4-BE49-F238E27FC236}">
                        <a16:creationId xmlns:a16="http://schemas.microsoft.com/office/drawing/2014/main" xmlns="" id="{E2597D9C-CDD3-3270-68E8-E03C5C269892}"/>
                      </a:ext>
                    </a:extLst>
                  </p:cNvPr>
                  <p:cNvSpPr/>
                  <p:nvPr/>
                </p:nvSpPr>
                <p:spPr>
                  <a:xfrm>
                    <a:off x="2243664" y="2619572"/>
                    <a:ext cx="940491" cy="155633"/>
                  </a:xfrm>
                  <a:prstGeom prst="rect">
                    <a:avLst/>
                  </a:prstGeom>
                  <a:solidFill>
                    <a:srgbClr val="92D05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zh-CN" altLang="en-US" dirty="0">
                      <a:solidFill>
                        <a:srgbClr val="FFFFFF"/>
                      </a:solidFill>
                      <a:latin typeface="Arial"/>
                      <a:ea typeface="宋体"/>
                    </a:endParaRPr>
                  </a:p>
                </p:txBody>
              </p:sp>
              <p:sp>
                <p:nvSpPr>
                  <p:cNvPr id="76" name="矩形 75">
                    <a:extLst>
                      <a:ext uri="{FF2B5EF4-FFF2-40B4-BE49-F238E27FC236}">
                        <a16:creationId xmlns:a16="http://schemas.microsoft.com/office/drawing/2014/main" xmlns="" id="{FE8F671C-391D-DA32-56C9-56B34E661A0C}"/>
                      </a:ext>
                    </a:extLst>
                  </p:cNvPr>
                  <p:cNvSpPr/>
                  <p:nvPr/>
                </p:nvSpPr>
                <p:spPr>
                  <a:xfrm>
                    <a:off x="3487855" y="2630689"/>
                    <a:ext cx="625361" cy="155633"/>
                  </a:xfrm>
                  <a:prstGeom prst="rect">
                    <a:avLst/>
                  </a:prstGeom>
                  <a:solidFill>
                    <a:srgbClr val="92D05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zh-CN" altLang="en-US" dirty="0">
                      <a:solidFill>
                        <a:srgbClr val="FFFFFF"/>
                      </a:solidFill>
                      <a:latin typeface="Arial"/>
                      <a:ea typeface="宋体"/>
                    </a:endParaRPr>
                  </a:p>
                </p:txBody>
              </p:sp>
              <p:sp>
                <p:nvSpPr>
                  <p:cNvPr id="77" name="矩形 76">
                    <a:extLst>
                      <a:ext uri="{FF2B5EF4-FFF2-40B4-BE49-F238E27FC236}">
                        <a16:creationId xmlns:a16="http://schemas.microsoft.com/office/drawing/2014/main" xmlns="" id="{A014841B-14AA-CDB1-6F29-563A873BD678}"/>
                      </a:ext>
                    </a:extLst>
                  </p:cNvPr>
                  <p:cNvSpPr/>
                  <p:nvPr/>
                </p:nvSpPr>
                <p:spPr>
                  <a:xfrm>
                    <a:off x="4725515" y="2619572"/>
                    <a:ext cx="362481" cy="134987"/>
                  </a:xfrm>
                  <a:prstGeom prst="rect">
                    <a:avLst/>
                  </a:prstGeom>
                  <a:solidFill>
                    <a:srgbClr val="92D05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zh-CN" altLang="en-US" dirty="0">
                      <a:solidFill>
                        <a:srgbClr val="FFFFFF"/>
                      </a:solidFill>
                      <a:latin typeface="Arial"/>
                      <a:ea typeface="宋体"/>
                    </a:endParaRPr>
                  </a:p>
                </p:txBody>
              </p:sp>
              <p:sp>
                <p:nvSpPr>
                  <p:cNvPr id="78" name="箭头: 五边形 77">
                    <a:extLst>
                      <a:ext uri="{FF2B5EF4-FFF2-40B4-BE49-F238E27FC236}">
                        <a16:creationId xmlns:a16="http://schemas.microsoft.com/office/drawing/2014/main" xmlns="" id="{E0D40E9A-8D1A-A65D-C90D-C42F5C5B78ED}"/>
                      </a:ext>
                    </a:extLst>
                  </p:cNvPr>
                  <p:cNvSpPr/>
                  <p:nvPr/>
                </p:nvSpPr>
                <p:spPr>
                  <a:xfrm>
                    <a:off x="5654576" y="2610044"/>
                    <a:ext cx="804969" cy="155633"/>
                  </a:xfrm>
                  <a:prstGeom prst="homePlate">
                    <a:avLst/>
                  </a:prstGeom>
                  <a:solidFill>
                    <a:srgbClr val="92D050"/>
                  </a:solidFill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fontAlgn="base">
                      <a:spcBef>
                        <a:spcPct val="0"/>
                      </a:spcBef>
                      <a:spcAft>
                        <a:spcPct val="0"/>
                      </a:spcAft>
                      <a:defRPr/>
                    </a:pPr>
                    <a:endParaRPr lang="zh-CN" altLang="en-US">
                      <a:solidFill>
                        <a:srgbClr val="FFFFFF"/>
                      </a:solidFill>
                      <a:latin typeface="Arial"/>
                      <a:ea typeface="宋体"/>
                    </a:endParaRPr>
                  </a:p>
                </p:txBody>
              </p:sp>
            </p:grpSp>
            <p:sp>
              <p:nvSpPr>
                <p:cNvPr id="68" name="文本框 5">
                  <a:extLst>
                    <a:ext uri="{FF2B5EF4-FFF2-40B4-BE49-F238E27FC236}">
                      <a16:creationId xmlns:a16="http://schemas.microsoft.com/office/drawing/2014/main" xmlns="" id="{F25784E0-032A-19A1-497E-BCD06242DBA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2624685" y="3306642"/>
                  <a:ext cx="332142" cy="33855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buNone/>
                  </a:pPr>
                  <a:r>
                    <a:rPr lang="en-US" altLang="zh-CN" sz="1600" b="1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</a:t>
                  </a:r>
                  <a:endParaRPr lang="zh-CN" altLang="en-US" sz="1600" b="1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xmlns="" id="{35BB82B8-42F3-F52A-3C5C-01986A904FF5}"/>
                  </a:ext>
                </a:extLst>
              </p:cNvPr>
              <p:cNvSpPr/>
              <p:nvPr/>
            </p:nvSpPr>
            <p:spPr>
              <a:xfrm>
                <a:off x="3035052" y="1818043"/>
                <a:ext cx="5407296" cy="151347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</p:grpSp>
      <p:sp>
        <p:nvSpPr>
          <p:cNvPr id="79" name="文本框 78">
            <a:extLst>
              <a:ext uri="{FF2B5EF4-FFF2-40B4-BE49-F238E27FC236}">
                <a16:creationId xmlns:a16="http://schemas.microsoft.com/office/drawing/2014/main" xmlns="" id="{CEC9FB87-93D2-98AF-6651-729311805AE4}"/>
              </a:ext>
            </a:extLst>
          </p:cNvPr>
          <p:cNvSpPr txBox="1"/>
          <p:nvPr/>
        </p:nvSpPr>
        <p:spPr>
          <a:xfrm>
            <a:off x="-16441" y="-19041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. S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815063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15615F03-FA7E-5BD7-6023-DA2709F5372B}"/>
              </a:ext>
            </a:extLst>
          </p:cNvPr>
          <p:cNvSpPr txBox="1"/>
          <p:nvPr/>
        </p:nvSpPr>
        <p:spPr>
          <a:xfrm>
            <a:off x="279400" y="14281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ig. </a:t>
            </a:r>
            <a:r>
              <a:rPr lang="en-US" altLang="zh-CN" smtClean="0"/>
              <a:t>S2</a:t>
            </a:r>
            <a:endParaRPr lang="zh-CN" altLang="en-US" dirty="0"/>
          </a:p>
        </p:txBody>
      </p:sp>
      <p:grpSp>
        <p:nvGrpSpPr>
          <p:cNvPr id="2" name="组合 1"/>
          <p:cNvGrpSpPr/>
          <p:nvPr/>
        </p:nvGrpSpPr>
        <p:grpSpPr>
          <a:xfrm>
            <a:off x="2478742" y="925009"/>
            <a:ext cx="6619861" cy="5523674"/>
            <a:chOff x="2057400" y="862257"/>
            <a:chExt cx="6619861" cy="5523674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xmlns="" id="{F50FA6D1-1464-133D-26C4-84B1E43633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0" t="9840" r="5037" b="9175"/>
            <a:stretch/>
          </p:blipFill>
          <p:spPr>
            <a:xfrm>
              <a:off x="5655733" y="1210733"/>
              <a:ext cx="1981200" cy="1769534"/>
            </a:xfrm>
            <a:prstGeom prst="rect">
              <a:avLst/>
            </a:prstGeom>
          </p:spPr>
        </p:pic>
        <p:pic>
          <p:nvPicPr>
            <p:cNvPr id="5" name="Picture 2">
              <a:extLst>
                <a:ext uri="{FF2B5EF4-FFF2-40B4-BE49-F238E27FC236}">
                  <a16:creationId xmlns:a16="http://schemas.microsoft.com/office/drawing/2014/main" xmlns="" id="{A899E661-8CEF-AA4E-2854-74D03EA4044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35" t="9774" r="8105" b="11875"/>
            <a:stretch/>
          </p:blipFill>
          <p:spPr bwMode="auto">
            <a:xfrm>
              <a:off x="2125133" y="1210733"/>
              <a:ext cx="2116069" cy="197000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xmlns="" id="{16EFF2BF-CE70-1514-7060-23ACEF6C0E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6" t="9028" r="5539" b="9818"/>
            <a:stretch/>
          </p:blipFill>
          <p:spPr>
            <a:xfrm>
              <a:off x="2057400" y="4106333"/>
              <a:ext cx="2243667" cy="2040467"/>
            </a:xfrm>
            <a:prstGeom prst="rect">
              <a:avLst/>
            </a:prstGeom>
          </p:spPr>
        </p:pic>
        <p:pic>
          <p:nvPicPr>
            <p:cNvPr id="7" name="Picture 4">
              <a:extLst>
                <a:ext uri="{FF2B5EF4-FFF2-40B4-BE49-F238E27FC236}">
                  <a16:creationId xmlns:a16="http://schemas.microsoft.com/office/drawing/2014/main" xmlns="" id="{F739CE9F-7C6D-9D7B-D17B-2AA2A42FC48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89" b="11327"/>
            <a:stretch/>
          </p:blipFill>
          <p:spPr bwMode="auto">
            <a:xfrm>
              <a:off x="5397333" y="4211396"/>
              <a:ext cx="2514334" cy="17695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xmlns="" id="{4A744C3D-45EA-1466-03F1-E2342C8AD667}"/>
                </a:ext>
              </a:extLst>
            </p:cNvPr>
            <p:cNvSpPr txBox="1"/>
            <p:nvPr/>
          </p:nvSpPr>
          <p:spPr>
            <a:xfrm>
              <a:off x="2429933" y="894117"/>
              <a:ext cx="681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n1a</a:t>
              </a:r>
              <a:endParaRPr lang="zh-CN" altLang="en-US" i="1" dirty="0"/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xmlns="" id="{7D1C2387-DF9D-B384-D179-AA71970ED809}"/>
                </a:ext>
              </a:extLst>
            </p:cNvPr>
            <p:cNvSpPr txBox="1"/>
            <p:nvPr/>
          </p:nvSpPr>
          <p:spPr>
            <a:xfrm>
              <a:off x="3289433" y="862257"/>
              <a:ext cx="5100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s3</a:t>
              </a:r>
              <a:endParaRPr lang="zh-CN" altLang="en-US" i="1" dirty="0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xmlns="" id="{19574BDB-09CE-ED0A-412E-82825B14864B}"/>
                </a:ext>
              </a:extLst>
            </p:cNvPr>
            <p:cNvSpPr txBox="1"/>
            <p:nvPr/>
          </p:nvSpPr>
          <p:spPr>
            <a:xfrm>
              <a:off x="2744390" y="3089538"/>
              <a:ext cx="1053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</a:t>
              </a:r>
              <a:r>
                <a:rPr lang="en-US" altLang="zh-CN" i="1" dirty="0" smtClean="0"/>
                <a:t>n1a-gs3</a:t>
              </a:r>
              <a:endParaRPr lang="zh-CN" altLang="en-US" i="1" dirty="0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xmlns="" id="{3D51FD20-5139-FF3A-687E-E9CE6587D798}"/>
                </a:ext>
              </a:extLst>
            </p:cNvPr>
            <p:cNvSpPr txBox="1"/>
            <p:nvPr/>
          </p:nvSpPr>
          <p:spPr>
            <a:xfrm>
              <a:off x="2501646" y="3847068"/>
              <a:ext cx="6062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ipa1</a:t>
              </a:r>
              <a:endParaRPr lang="zh-CN" altLang="en-US" i="1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xmlns="" id="{A5D2F97C-58E1-616D-92ED-245F7DA21675}"/>
                </a:ext>
              </a:extLst>
            </p:cNvPr>
            <p:cNvSpPr txBox="1"/>
            <p:nvPr/>
          </p:nvSpPr>
          <p:spPr>
            <a:xfrm>
              <a:off x="3453771" y="3842064"/>
              <a:ext cx="5100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s3</a:t>
              </a:r>
              <a:endParaRPr lang="zh-CN" altLang="en-US" i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xmlns="" id="{E55D65C1-D9FE-1187-710C-029476C92622}"/>
                </a:ext>
              </a:extLst>
            </p:cNvPr>
            <p:cNvSpPr txBox="1"/>
            <p:nvPr/>
          </p:nvSpPr>
          <p:spPr>
            <a:xfrm>
              <a:off x="2733061" y="6016599"/>
              <a:ext cx="9877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</a:t>
              </a:r>
              <a:r>
                <a:rPr lang="en-US" altLang="zh-CN" i="1" dirty="0" smtClean="0"/>
                <a:t>s3-ipa1</a:t>
              </a:r>
              <a:endParaRPr lang="zh-CN" altLang="en-US" i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xmlns="" id="{FAE84C26-9848-0E0D-018A-37894F2AB812}"/>
                </a:ext>
              </a:extLst>
            </p:cNvPr>
            <p:cNvSpPr txBox="1"/>
            <p:nvPr/>
          </p:nvSpPr>
          <p:spPr>
            <a:xfrm>
              <a:off x="5972904" y="894117"/>
              <a:ext cx="681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n1a</a:t>
              </a:r>
              <a:endParaRPr lang="zh-CN" altLang="en-US" i="1" dirty="0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xmlns="" id="{24AF6219-14FB-8E22-33C9-697BB729FF9A}"/>
                </a:ext>
              </a:extLst>
            </p:cNvPr>
            <p:cNvSpPr txBox="1"/>
            <p:nvPr/>
          </p:nvSpPr>
          <p:spPr>
            <a:xfrm>
              <a:off x="6756400" y="894117"/>
              <a:ext cx="6062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ipa1</a:t>
              </a:r>
              <a:endParaRPr lang="zh-CN" altLang="en-US" i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xmlns="" id="{7FAB8BEE-C46D-FF95-D6E1-D3EB773F5F02}"/>
                </a:ext>
              </a:extLst>
            </p:cNvPr>
            <p:cNvSpPr txBox="1"/>
            <p:nvPr/>
          </p:nvSpPr>
          <p:spPr>
            <a:xfrm>
              <a:off x="6100624" y="2864715"/>
              <a:ext cx="11352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</a:t>
              </a:r>
              <a:r>
                <a:rPr lang="en-US" altLang="zh-CN" i="1" dirty="0" smtClean="0"/>
                <a:t>n1a-ipa1</a:t>
              </a:r>
              <a:endParaRPr lang="zh-CN" altLang="en-US" i="1" dirty="0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xmlns="" id="{0955EAED-4E30-289E-D366-CCF0E3185C4D}"/>
                </a:ext>
              </a:extLst>
            </p:cNvPr>
            <p:cNvSpPr txBox="1"/>
            <p:nvPr/>
          </p:nvSpPr>
          <p:spPr>
            <a:xfrm>
              <a:off x="7146073" y="5647267"/>
              <a:ext cx="1531188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</a:t>
              </a:r>
              <a:r>
                <a:rPr lang="en-US" altLang="zh-CN" i="1" dirty="0" smtClean="0"/>
                <a:t>n1a-gs3-ipa1</a:t>
              </a:r>
              <a:endParaRPr lang="zh-CN" altLang="en-US" i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xmlns="" id="{634F2A12-5C04-769C-FAFD-93C51CEB3B54}"/>
                </a:ext>
              </a:extLst>
            </p:cNvPr>
            <p:cNvSpPr txBox="1"/>
            <p:nvPr/>
          </p:nvSpPr>
          <p:spPr>
            <a:xfrm>
              <a:off x="5845586" y="3657398"/>
              <a:ext cx="5100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s3</a:t>
              </a:r>
              <a:endParaRPr lang="zh-CN" altLang="en-US" i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xmlns="" id="{9DB46134-6AE4-5BFC-AD31-236A2299C3EB}"/>
                </a:ext>
              </a:extLst>
            </p:cNvPr>
            <p:cNvSpPr txBox="1"/>
            <p:nvPr/>
          </p:nvSpPr>
          <p:spPr>
            <a:xfrm>
              <a:off x="6895072" y="3657398"/>
              <a:ext cx="68159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i="1" dirty="0"/>
                <a:t>gn1a</a:t>
              </a:r>
              <a:endParaRPr lang="zh-CN" altLang="en-US" i="1" dirty="0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xmlns="" id="{20B81508-DDF8-F9C0-8DDD-1775A3F194D0}"/>
                </a:ext>
              </a:extLst>
            </p:cNvPr>
            <p:cNvSpPr txBox="1"/>
            <p:nvPr/>
          </p:nvSpPr>
          <p:spPr>
            <a:xfrm>
              <a:off x="5366648" y="5664699"/>
              <a:ext cx="60625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zh-CN" i="1" dirty="0"/>
                <a:t>ipa1</a:t>
              </a:r>
              <a:endParaRPr lang="zh-CN" altLang="en-US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25404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2</TotalTime>
  <Words>59</Words>
  <Application>Microsoft Office PowerPoint</Application>
  <PresentationFormat>宽屏</PresentationFormat>
  <Paragraphs>2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黄 逸斌</dc:creator>
  <cp:lastModifiedBy>hzx</cp:lastModifiedBy>
  <cp:revision>6</cp:revision>
  <dcterms:created xsi:type="dcterms:W3CDTF">2022-07-10T01:17:03Z</dcterms:created>
  <dcterms:modified xsi:type="dcterms:W3CDTF">2022-07-20T08:33:32Z</dcterms:modified>
</cp:coreProperties>
</file>